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906000" cy="6858000" type="A4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3" userDrawn="1">
          <p15:clr>
            <a:srgbClr val="A4A3A4"/>
          </p15:clr>
        </p15:guide>
        <p15:guide id="2" pos="81" userDrawn="1">
          <p15:clr>
            <a:srgbClr val="A4A3A4"/>
          </p15:clr>
        </p15:guide>
        <p15:guide id="3" orient="horz" pos="20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70" autoAdjust="0"/>
    <p:restoredTop sz="94660"/>
  </p:normalViewPr>
  <p:slideViewPr>
    <p:cSldViewPr snapToGrid="0">
      <p:cViewPr>
        <p:scale>
          <a:sx n="100" d="100"/>
          <a:sy n="100" d="100"/>
        </p:scale>
        <p:origin x="-2124" y="-324"/>
      </p:cViewPr>
      <p:guideLst>
        <p:guide orient="horz" pos="2183"/>
        <p:guide orient="horz" pos="2027"/>
        <p:guide pos="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2F3F5-0ECE-4623-8A46-209D33A92747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741363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D8DD9-1C24-4B35-9623-BDD78EDCC8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461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25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465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25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019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2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15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58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39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9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04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2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3" name="Rectangle 342"/>
          <p:cNvSpPr/>
          <p:nvPr/>
        </p:nvSpPr>
        <p:spPr>
          <a:xfrm>
            <a:off x="345747" y="5906079"/>
            <a:ext cx="921450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+mj-lt"/>
                <a:cs typeface="Times New Roman" panose="02020603050405020304" pitchFamily="18" charset="0"/>
              </a:rPr>
              <a:t>Supplementary Figure 2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– IVIS images of livers excised from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hHGF-ki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mice that received intra-pancreatic injection of Capan-1 cells. Mice </a:t>
            </a:r>
            <a:r>
              <a:rPr lang="en-US" sz="1200" dirty="0" smtClean="0"/>
              <a:t>were </a:t>
            </a:r>
            <a:r>
              <a:rPr lang="en-US" sz="1200" dirty="0"/>
              <a:t>treated by intraperitoneal injection of </a:t>
            </a:r>
            <a:r>
              <a:rPr lang="en-US" sz="1200" dirty="0" smtClean="0"/>
              <a:t>VEHICLE </a:t>
            </a:r>
            <a:r>
              <a:rPr lang="en-US" sz="1200" dirty="0"/>
              <a:t>or the indicated molecules. COMBO: MvDN30 + decoyMET</a:t>
            </a:r>
            <a:r>
              <a:rPr lang="en-US" sz="1200" baseline="30000" dirty="0"/>
              <a:t>K842E</a:t>
            </a:r>
            <a:r>
              <a:rPr lang="en-US" sz="1200" dirty="0"/>
              <a:t>.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Images reported in panel A and B correspond to the experiments quantified in Fig. 4A and B, respectively.</a:t>
            </a:r>
            <a:endParaRPr lang="en-US" sz="1200" dirty="0">
              <a:latin typeface="+mj-lt"/>
              <a:cs typeface="Times New Roman" panose="02020603050405020304" pitchFamily="18" charset="0"/>
            </a:endParaRPr>
          </a:p>
        </p:txBody>
      </p:sp>
      <p:grpSp>
        <p:nvGrpSpPr>
          <p:cNvPr id="24" name="Gruppo 23"/>
          <p:cNvGrpSpPr/>
          <p:nvPr/>
        </p:nvGrpSpPr>
        <p:grpSpPr>
          <a:xfrm>
            <a:off x="275706" y="502520"/>
            <a:ext cx="4058050" cy="4962200"/>
            <a:chOff x="-74431" y="651382"/>
            <a:chExt cx="4058050" cy="4962200"/>
          </a:xfrm>
        </p:grpSpPr>
        <p:sp>
          <p:nvSpPr>
            <p:cNvPr id="348" name="CasellaDiTesto 347"/>
            <p:cNvSpPr txBox="1"/>
            <p:nvPr/>
          </p:nvSpPr>
          <p:spPr>
            <a:xfrm>
              <a:off x="-74431" y="651382"/>
              <a:ext cx="365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/>
                <a:t>A</a:t>
              </a:r>
              <a:endParaRPr lang="it-IT" sz="1600" dirty="0"/>
            </a:p>
          </p:txBody>
        </p:sp>
        <p:grpSp>
          <p:nvGrpSpPr>
            <p:cNvPr id="22" name="Gruppo 21"/>
            <p:cNvGrpSpPr/>
            <p:nvPr/>
          </p:nvGrpSpPr>
          <p:grpSpPr>
            <a:xfrm>
              <a:off x="391306" y="1030979"/>
              <a:ext cx="3592313" cy="4582603"/>
              <a:chOff x="391306" y="1030979"/>
              <a:chExt cx="3592313" cy="4582603"/>
            </a:xfrm>
          </p:grpSpPr>
          <p:grpSp>
            <p:nvGrpSpPr>
              <p:cNvPr id="14" name="Gruppo 13"/>
              <p:cNvGrpSpPr/>
              <p:nvPr/>
            </p:nvGrpSpPr>
            <p:grpSpPr>
              <a:xfrm>
                <a:off x="396407" y="3305380"/>
                <a:ext cx="3579580" cy="1166658"/>
                <a:chOff x="396407" y="3305380"/>
                <a:chExt cx="3579580" cy="1166658"/>
              </a:xfrm>
            </p:grpSpPr>
            <p:sp>
              <p:nvSpPr>
                <p:cNvPr id="450" name="TextBox 44"/>
                <p:cNvSpPr txBox="1"/>
                <p:nvPr/>
              </p:nvSpPr>
              <p:spPr>
                <a:xfrm>
                  <a:off x="396407" y="3305380"/>
                  <a:ext cx="88036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DecAb-L1</a:t>
                  </a:r>
                  <a:endParaRPr lang="it-IT" sz="1400" dirty="0"/>
                </a:p>
              </p:txBody>
            </p:sp>
            <p:pic>
              <p:nvPicPr>
                <p:cNvPr id="437" name="Picture 9" descr="K:\## Gene Transfer and Therapy\Elisa Vigna\Met-HGF-ott2018\Shared\in vivo\EXP_Fusion_Proteins\Capan\20180516\cage C\dxsx\Liver JER20180516170450_SEQ\JER20180516170450_SEQ.PNG"/>
                <p:cNvPicPr>
                  <a:picLocks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225" t="21478" r="36153" b="41489"/>
                <a:stretch/>
              </p:blipFill>
              <p:spPr bwMode="auto">
                <a:xfrm>
                  <a:off x="1161367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38" name="Picture 10" descr="K:\## Gene Transfer and Therapy\Elisa Vigna\Met-HGF-ott2018\Shared\in vivo\EXP_Fusion_Proteins\Capan\20180516\cage C\2dx\liver JER20180516165519_SEQ\JER20180516165519_SEQ.PNG"/>
                <p:cNvPicPr>
                  <a:picLocks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812" t="23936" r="40961" b="34467"/>
                <a:stretch/>
              </p:blipFill>
              <p:spPr bwMode="auto">
                <a:xfrm>
                  <a:off x="1859357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39" name="Picture 11" descr="K:\## Gene Transfer and Therapy\Elisa Vigna\Met-HGF-ott2018\Shared\in vivo\EXP_Fusion_Proteins\Capan\20180516\cage C\2sx\Liver JER20180516164325_SEQ\JER20180516164325_SEQ.PNG"/>
                <p:cNvPicPr>
                  <a:picLocks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627" t="29728" r="35918" b="37275"/>
                <a:stretch/>
              </p:blipFill>
              <p:spPr bwMode="auto">
                <a:xfrm>
                  <a:off x="2557347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45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2506618" y="4195039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58E+04</a:t>
                  </a:r>
                  <a:endParaRPr lang="it-IT" sz="1200" dirty="0"/>
                </a:p>
              </p:txBody>
            </p:sp>
            <p:sp>
              <p:nvSpPr>
                <p:cNvPr id="446" name="TextBox 32">
                  <a:extLst>
                    <a:ext uri="{FF2B5EF4-FFF2-40B4-BE49-F238E27FC236}">
                      <a16:creationId xmlns:a16="http://schemas.microsoft.com/office/drawing/2014/main" xmlns="" id="{615783A9-72BD-4FF3-99B1-573FD2D45ADC}"/>
                    </a:ext>
                  </a:extLst>
                </p:cNvPr>
                <p:cNvSpPr txBox="1"/>
                <p:nvPr/>
              </p:nvSpPr>
              <p:spPr>
                <a:xfrm>
                  <a:off x="3207828" y="4195039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3.20E+05</a:t>
                  </a:r>
                  <a:endParaRPr lang="it-IT" sz="1200" dirty="0"/>
                </a:p>
              </p:txBody>
            </p:sp>
            <p:sp>
              <p:nvSpPr>
                <p:cNvPr id="447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402964" y="4195039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70E+04</a:t>
                  </a:r>
                  <a:endParaRPr lang="it-IT" sz="1200" dirty="0"/>
                </a:p>
              </p:txBody>
            </p:sp>
            <p:sp>
              <p:nvSpPr>
                <p:cNvPr id="448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1116267" y="4195039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4.32E+04</a:t>
                  </a:r>
                  <a:endParaRPr lang="it-IT" sz="1200" dirty="0"/>
                </a:p>
              </p:txBody>
            </p:sp>
            <p:sp>
              <p:nvSpPr>
                <p:cNvPr id="449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1807273" y="4195039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5.92E+03</a:t>
                  </a:r>
                  <a:endParaRPr lang="it-IT" sz="1200" dirty="0"/>
                </a:p>
              </p:txBody>
            </p:sp>
            <p:pic>
              <p:nvPicPr>
                <p:cNvPr id="466" name="Picture 7" descr="K:\## Gene Transfer and Therapy\Elisa Vigna\Met-HGF-ott2018\Shared\in vivo\EXP_Fusion_Proteins\Capan\20180516\cage C\dx\Liver JER20180516163249_SEQ\JER20180516163249_SEQ.PNG"/>
                <p:cNvPicPr>
                  <a:picLocks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207" t="20952" r="34745" b="46578"/>
                <a:stretch/>
              </p:blipFill>
              <p:spPr bwMode="auto">
                <a:xfrm>
                  <a:off x="463377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7" name="Picture 8" descr="K:\## Gene Transfer and Therapy\Elisa Vigna\Met-HGF-ott2018\Shared\in vivo\EXP_Fusion_Proteins\Capan\20180516\cage C\NL\Liver JER20180516171407_SEQ\JER20180516171407_001\JER20180516171407_001.PNG"/>
                <p:cNvPicPr>
                  <a:picLocks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281" t="22418" r="42641" b="41022"/>
                <a:stretch/>
              </p:blipFill>
              <p:spPr bwMode="auto">
                <a:xfrm>
                  <a:off x="3255336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15" name="Gruppo 14"/>
              <p:cNvGrpSpPr/>
              <p:nvPr/>
            </p:nvGrpSpPr>
            <p:grpSpPr>
              <a:xfrm>
                <a:off x="395756" y="4448121"/>
                <a:ext cx="3587863" cy="1165461"/>
                <a:chOff x="395756" y="4448121"/>
                <a:chExt cx="3587863" cy="1165461"/>
              </a:xfrm>
            </p:grpSpPr>
            <p:sp>
              <p:nvSpPr>
                <p:cNvPr id="451" name="TextBox 45"/>
                <p:cNvSpPr txBox="1"/>
                <p:nvPr/>
              </p:nvSpPr>
              <p:spPr>
                <a:xfrm>
                  <a:off x="396407" y="4448121"/>
                  <a:ext cx="88036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AbDec-L1</a:t>
                  </a:r>
                  <a:endParaRPr lang="it-IT" sz="1400" dirty="0"/>
                </a:p>
              </p:txBody>
            </p:sp>
            <p:pic>
              <p:nvPicPr>
                <p:cNvPr id="452" name="Picture 14" descr="K:\## Gene Transfer and Therapy\Elisa Vigna\Met-HGF-ott2018\Shared\in vivo\EXP_Fusion_Proteins\Capan\20180516\cage D\dx\Liver JER20180516160833_SEQ\JER20180516160833_SEQ.PNG"/>
                <p:cNvPicPr>
                  <a:picLocks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979" t="23585" r="38732" b="36047"/>
                <a:stretch/>
              </p:blipFill>
              <p:spPr bwMode="auto">
                <a:xfrm>
                  <a:off x="463377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3" name="Picture 15" descr="K:\## Gene Transfer and Therapy\Elisa Vigna\Met-HGF-ott2018\Shared\in vivo\EXP_Fusion_Proteins\Capan\20180516\cage D\sx\liver JER20180516155853_SEQ\JER20180516155853_SEQ.PNG"/>
                <p:cNvPicPr>
                  <a:picLocks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040" t="28850" r="37912" b="41839"/>
                <a:stretch/>
              </p:blipFill>
              <p:spPr bwMode="auto">
                <a:xfrm>
                  <a:off x="1161367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4" name="Picture 16" descr="K:\## Gene Transfer and Therapy\Elisa Vigna\Met-HGF-ott2018\Shared\in vivo\EXP_Fusion_Proteins\Capan\20180516\cage D\dxsx\Liver JER20180516154015_SEQ\JER20180516154015_SEQ.PNG"/>
                <p:cNvPicPr>
                  <a:picLocks noChangeArrowheads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151" t="22531" r="35566" b="42014"/>
                <a:stretch/>
              </p:blipFill>
              <p:spPr bwMode="auto">
                <a:xfrm>
                  <a:off x="1859357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5" name="Picture 17" descr="K:\## Gene Transfer and Therapy\Elisa Vigna\Met-HGF-ott2018\Shared\in vivo\EXP_Fusion_Proteins\Capan\20180516\cage D\2dx\Liver JER20180516162032_SEQ\JER20180516162032_SEQ.PNG"/>
                <p:cNvPicPr>
                  <a:picLocks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917" t="31483" r="34745" b="36047"/>
                <a:stretch/>
              </p:blipFill>
              <p:spPr bwMode="auto">
                <a:xfrm>
                  <a:off x="2557347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56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2501012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8.17E+03</a:t>
                  </a:r>
                  <a:endParaRPr lang="it-IT" sz="1200" dirty="0"/>
                </a:p>
              </p:txBody>
            </p:sp>
            <p:sp>
              <p:nvSpPr>
                <p:cNvPr id="457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395756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8.74E+03</a:t>
                  </a:r>
                  <a:endParaRPr lang="it-IT" sz="1200" dirty="0"/>
                </a:p>
              </p:txBody>
            </p:sp>
            <p:sp>
              <p:nvSpPr>
                <p:cNvPr id="458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1116310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2.48E+04</a:t>
                  </a:r>
                  <a:endParaRPr lang="it-IT" sz="1200" dirty="0"/>
                </a:p>
              </p:txBody>
            </p:sp>
            <p:sp>
              <p:nvSpPr>
                <p:cNvPr id="459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1799259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9.26E+03</a:t>
                  </a:r>
                  <a:endParaRPr lang="it-IT" sz="1200" dirty="0"/>
                </a:p>
              </p:txBody>
            </p:sp>
            <p:pic>
              <p:nvPicPr>
                <p:cNvPr id="1026" name="Picture 2" descr="K:\## Gene Transfer and Therapy\Elisa Vigna\Met-HGF and microenviroment\Shared\Chiara\in vivo\EXP_Fusion_Proteins\Capan\20180516\cage D\2dx\Liver JER20180516162032_SEQ\JER20180516162032_SEQ.PNG"/>
                <p:cNvPicPr>
                  <a:picLocks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353" t="29858" r="35332" b="34268"/>
                <a:stretch/>
              </p:blipFill>
              <p:spPr bwMode="auto">
                <a:xfrm>
                  <a:off x="3255336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87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3215460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9.26E+03</a:t>
                  </a:r>
                  <a:endParaRPr lang="it-IT" sz="1200" dirty="0"/>
                </a:p>
              </p:txBody>
            </p:sp>
          </p:grpSp>
          <p:sp>
            <p:nvSpPr>
              <p:cNvPr id="430" name="TextBox 32">
                <a:extLst>
                  <a:ext uri="{FF2B5EF4-FFF2-40B4-BE49-F238E27FC236}">
                    <a16:creationId xmlns:a16="http://schemas.microsoft.com/office/drawing/2014/main" xmlns="" id="{615783A9-72BD-4FF3-99B1-573FD2D45ADC}"/>
                  </a:ext>
                </a:extLst>
              </p:cNvPr>
              <p:cNvSpPr txBox="1"/>
              <p:nvPr/>
            </p:nvSpPr>
            <p:spPr>
              <a:xfrm>
                <a:off x="3189844" y="1906835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6.41E+04</a:t>
                </a:r>
                <a:endParaRPr lang="it-IT" sz="1200" dirty="0"/>
              </a:p>
            </p:txBody>
          </p:sp>
          <p:grpSp>
            <p:nvGrpSpPr>
              <p:cNvPr id="12" name="Gruppo 11"/>
              <p:cNvGrpSpPr/>
              <p:nvPr/>
            </p:nvGrpSpPr>
            <p:grpSpPr>
              <a:xfrm>
                <a:off x="395756" y="1030979"/>
                <a:ext cx="3507580" cy="1152855"/>
                <a:chOff x="395756" y="1030979"/>
                <a:chExt cx="3507580" cy="1152855"/>
              </a:xfrm>
            </p:grpSpPr>
            <p:sp>
              <p:nvSpPr>
                <p:cNvPr id="391" name="TextBox 5"/>
                <p:cNvSpPr txBox="1"/>
                <p:nvPr/>
              </p:nvSpPr>
              <p:spPr>
                <a:xfrm>
                  <a:off x="396407" y="1030979"/>
                  <a:ext cx="79220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VEHICLE</a:t>
                  </a:r>
                  <a:endParaRPr lang="it-IT" sz="1400" dirty="0"/>
                </a:p>
              </p:txBody>
            </p:sp>
            <p:sp>
              <p:nvSpPr>
                <p:cNvPr id="429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2489335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06E+05</a:t>
                  </a:r>
                  <a:endParaRPr lang="it-IT" sz="1200" dirty="0"/>
                </a:p>
              </p:txBody>
            </p:sp>
            <p:sp>
              <p:nvSpPr>
                <p:cNvPr id="431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395756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4.40E+04</a:t>
                  </a:r>
                  <a:endParaRPr lang="it-IT" sz="1200" dirty="0"/>
                </a:p>
              </p:txBody>
            </p:sp>
            <p:sp>
              <p:nvSpPr>
                <p:cNvPr id="432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1118831" y="1906835"/>
                  <a:ext cx="6896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3E+06</a:t>
                  </a:r>
                  <a:endParaRPr lang="it-IT" sz="1200" dirty="0"/>
                </a:p>
              </p:txBody>
            </p:sp>
            <p:sp>
              <p:nvSpPr>
                <p:cNvPr id="433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1792275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40E+06</a:t>
                  </a:r>
                  <a:endParaRPr lang="it-IT" sz="1200" dirty="0"/>
                </a:p>
              </p:txBody>
            </p:sp>
            <p:pic>
              <p:nvPicPr>
                <p:cNvPr id="460" name="Picture 2" descr="K:\## Gene Transfer and Therapy\Elisa Vigna\Met-HGF-ott2018\Shared\in vivo\EXP_Fusion_Proteins\Capan\20180516\Cage A1\dx\JER20180516152934_001\JER20180516152934_001.PNG"/>
                <p:cNvPicPr>
                  <a:picLocks noChangeArrowheads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882" t="24941" r="42685" b="39580"/>
                <a:stretch/>
              </p:blipFill>
              <p:spPr bwMode="auto">
                <a:xfrm>
                  <a:off x="463377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1" name="Picture 3" descr="K:\## Gene Transfer and Therapy\Elisa Vigna\Met-HGF-ott2018\Shared\in vivo\EXP_Fusion_Proteins\Capan\20180516\Cage A1\2sx\Liver JER20180516152253_SEQ\JER20180516152253_001\JER20180516152253_001.PNG"/>
                <p:cNvPicPr>
                  <a:picLocks noChangeArrowheads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796" t="27393" r="45478" b="37994"/>
                <a:stretch/>
              </p:blipFill>
              <p:spPr bwMode="auto">
                <a:xfrm>
                  <a:off x="1161367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2" name="Picture 4" descr="K:\## Gene Transfer and Therapy\Elisa Vigna\Met-HGF-ott2018\Shared\in vivo\EXP_Fusion_Proteins\Capan\20180516\Cage A1\NL\Liver JER20180516151351_SEQ\JER20180516151351_001\JER20180516151351_001.PNG"/>
                <p:cNvPicPr>
                  <a:picLocks noChangeArrowheads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699" t="34315" r="41739" b="38643"/>
                <a:stretch/>
              </p:blipFill>
              <p:spPr bwMode="auto">
                <a:xfrm>
                  <a:off x="1859357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3" name="Picture 5" descr="K:\## Gene Transfer and Therapy\Elisa Vigna\Met-HGF-ott2018\Shared\in vivo\EXP_Fusion_Proteins\Capan\20180516\cage A2\dxsx\JER20180517142651_001\JER20180517142651_001.PNG"/>
                <p:cNvPicPr>
                  <a:picLocks noChangeArrowheads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574" t="23499" r="48185" b="42969"/>
                <a:stretch/>
              </p:blipFill>
              <p:spPr bwMode="auto">
                <a:xfrm>
                  <a:off x="2557347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5" name="Picture 6" descr="K:\## Gene Transfer and Therapy\Elisa Vigna\Met-HGF-ott2018\Shared\in vivo\EXP_Fusion_Proteins\Capan\20180516\cage A2\NL\liver JER20180517143619_SEQ\JER20180517143619_001\JER20180517143619_001.PNG"/>
                <p:cNvPicPr>
                  <a:picLocks noChangeArrowheads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507" t="20254" r="43802" b="38426"/>
                <a:stretch/>
              </p:blipFill>
              <p:spPr bwMode="auto">
                <a:xfrm>
                  <a:off x="3255336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13" name="Gruppo 12"/>
              <p:cNvGrpSpPr/>
              <p:nvPr/>
            </p:nvGrpSpPr>
            <p:grpSpPr>
              <a:xfrm>
                <a:off x="391306" y="2163360"/>
                <a:ext cx="2877865" cy="1162090"/>
                <a:chOff x="391306" y="2163360"/>
                <a:chExt cx="2877865" cy="1162090"/>
              </a:xfrm>
            </p:grpSpPr>
            <p:pic>
              <p:nvPicPr>
                <p:cNvPr id="1027" name="Picture 3" descr="K:\## Gene Transfer and Therapy\Elisa Vigna\Met-HGF and microenviroment\Shared\Chiara\in vivo\EXP_Fusion_Proteins\Capan\20180516\cage B\2dx JER20180516145836_001.PNG"/>
                <p:cNvPicPr>
                  <a:picLocks noChangeArrowheads="1"/>
                </p:cNvPicPr>
                <p:nvPr/>
              </p:nvPicPr>
              <p:blipFill rotWithShape="1"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022" t="38221" r="41939" b="22636"/>
                <a:stretch/>
              </p:blipFill>
              <p:spPr bwMode="auto">
                <a:xfrm>
                  <a:off x="463377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28" name="Picture 4" descr="K:\## Gene Transfer and Therapy\Elisa Vigna\Met-HGF and microenviroment\Shared\Chiara\in vivo\EXP_Fusion_Proteins\Capan\20180516\cage B\2sx JER20180516144143_001.PNG"/>
                <p:cNvPicPr>
                  <a:picLocks noChangeArrowheads="1"/>
                </p:cNvPicPr>
                <p:nvPr/>
              </p:nvPicPr>
              <p:blipFill rotWithShape="1"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318" t="34838" r="41507" b="22395"/>
                <a:stretch/>
              </p:blipFill>
              <p:spPr bwMode="auto">
                <a:xfrm>
                  <a:off x="1161367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29" name="Picture 5" descr="K:\## Gene Transfer and Therapy\Elisa Vigna\Met-HGF and microenviroment\Shared\Chiara\in vivo\EXP_Fusion_Proteins\Capan\20180516\cage B\dxsx JER20180516143150_001.PNG"/>
                <p:cNvPicPr>
                  <a:picLocks noChangeArrowheads="1"/>
                </p:cNvPicPr>
                <p:nvPr/>
              </p:nvPicPr>
              <p:blipFill rotWithShape="1">
                <a:blip r:embed="rId1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718" t="56584" r="42227" b="6690"/>
                <a:stretch/>
              </p:blipFill>
              <p:spPr bwMode="auto">
                <a:xfrm>
                  <a:off x="1859357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0" name="Picture 6" descr="K:\## Gene Transfer and Therapy\Elisa Vigna\Met-HGF and microenviroment\Shared\Chiara\in vivo\EXP_Fusion_Proteins\Capan\20180516\cage B\dx JER20180516144959_001.PNG"/>
                <p:cNvPicPr>
                  <a:picLocks noChangeArrowheads="1"/>
                </p:cNvPicPr>
                <p:nvPr/>
              </p:nvPicPr>
              <p:blipFill rotWithShape="1"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022" t="28315" r="43091" b="30610"/>
                <a:stretch/>
              </p:blipFill>
              <p:spPr bwMode="auto">
                <a:xfrm>
                  <a:off x="2557347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9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2501012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2.57E+04</a:t>
                  </a:r>
                  <a:endParaRPr lang="it-IT" sz="1200" dirty="0"/>
                </a:p>
              </p:txBody>
            </p:sp>
            <p:sp>
              <p:nvSpPr>
                <p:cNvPr id="100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391306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2.29E+03</a:t>
                  </a:r>
                  <a:endParaRPr lang="it-IT" sz="1200" dirty="0"/>
                </a:p>
              </p:txBody>
            </p:sp>
            <p:sp>
              <p:nvSpPr>
                <p:cNvPr id="101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1100408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82E+04</a:t>
                  </a:r>
                  <a:endParaRPr lang="it-IT" sz="1200" dirty="0"/>
                </a:p>
              </p:txBody>
            </p:sp>
            <p:sp>
              <p:nvSpPr>
                <p:cNvPr id="102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1799263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58E+04</a:t>
                  </a:r>
                  <a:endParaRPr lang="it-IT" sz="1200" dirty="0"/>
                </a:p>
              </p:txBody>
            </p:sp>
            <p:sp>
              <p:nvSpPr>
                <p:cNvPr id="104" name="TextBox 45"/>
                <p:cNvSpPr txBox="1"/>
                <p:nvPr/>
              </p:nvSpPr>
              <p:spPr>
                <a:xfrm>
                  <a:off x="396407" y="2163360"/>
                  <a:ext cx="77963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COMBO</a:t>
                  </a:r>
                  <a:endParaRPr lang="it-IT" sz="1400" dirty="0"/>
                </a:p>
              </p:txBody>
            </p:sp>
          </p:grpSp>
        </p:grpSp>
      </p:grpSp>
      <p:grpSp>
        <p:nvGrpSpPr>
          <p:cNvPr id="25" name="Gruppo 24"/>
          <p:cNvGrpSpPr/>
          <p:nvPr/>
        </p:nvGrpSpPr>
        <p:grpSpPr>
          <a:xfrm>
            <a:off x="4758310" y="502520"/>
            <a:ext cx="4833264" cy="4962200"/>
            <a:chOff x="4758310" y="651382"/>
            <a:chExt cx="4833264" cy="4962200"/>
          </a:xfrm>
        </p:grpSpPr>
        <p:sp>
          <p:nvSpPr>
            <p:cNvPr id="347" name="CasellaDiTesto 346"/>
            <p:cNvSpPr txBox="1"/>
            <p:nvPr/>
          </p:nvSpPr>
          <p:spPr>
            <a:xfrm>
              <a:off x="4758310" y="651382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B</a:t>
              </a:r>
              <a:endParaRPr lang="en-GB" sz="1600" dirty="0"/>
            </a:p>
          </p:txBody>
        </p:sp>
        <p:grpSp>
          <p:nvGrpSpPr>
            <p:cNvPr id="23" name="Gruppo 22"/>
            <p:cNvGrpSpPr/>
            <p:nvPr/>
          </p:nvGrpSpPr>
          <p:grpSpPr>
            <a:xfrm>
              <a:off x="5297399" y="1030979"/>
              <a:ext cx="4294175" cy="4582603"/>
              <a:chOff x="5297399" y="1030979"/>
              <a:chExt cx="4294175" cy="4582603"/>
            </a:xfrm>
          </p:grpSpPr>
          <p:grpSp>
            <p:nvGrpSpPr>
              <p:cNvPr id="17" name="Gruppo 16"/>
              <p:cNvGrpSpPr/>
              <p:nvPr/>
            </p:nvGrpSpPr>
            <p:grpSpPr>
              <a:xfrm>
                <a:off x="5317570" y="1030979"/>
                <a:ext cx="4274004" cy="1152855"/>
                <a:chOff x="5317570" y="1030979"/>
                <a:chExt cx="4274004" cy="1152855"/>
              </a:xfrm>
            </p:grpSpPr>
            <p:sp>
              <p:nvSpPr>
                <p:cNvPr id="513" name="TextBox 5"/>
                <p:cNvSpPr txBox="1"/>
                <p:nvPr/>
              </p:nvSpPr>
              <p:spPr>
                <a:xfrm>
                  <a:off x="5317570" y="1030979"/>
                  <a:ext cx="79220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VEHICLE</a:t>
                  </a:r>
                  <a:endParaRPr lang="it-IT" sz="1400" dirty="0"/>
                </a:p>
              </p:txBody>
            </p:sp>
            <p:sp>
              <p:nvSpPr>
                <p:cNvPr id="521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6739941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5.54E+04</a:t>
                  </a:r>
                  <a:endParaRPr lang="it-IT" sz="1200" dirty="0"/>
                </a:p>
              </p:txBody>
            </p:sp>
            <p:sp>
              <p:nvSpPr>
                <p:cNvPr id="522" name="TextBox 32">
                  <a:extLst>
                    <a:ext uri="{FF2B5EF4-FFF2-40B4-BE49-F238E27FC236}">
                      <a16:creationId xmlns:a16="http://schemas.microsoft.com/office/drawing/2014/main" xmlns="" id="{615783A9-72BD-4FF3-99B1-573FD2D45ADC}"/>
                    </a:ext>
                  </a:extLst>
                </p:cNvPr>
                <p:cNvSpPr txBox="1"/>
                <p:nvPr/>
              </p:nvSpPr>
              <p:spPr>
                <a:xfrm>
                  <a:off x="7421989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03E+05</a:t>
                  </a:r>
                  <a:endParaRPr lang="it-IT" sz="1200" dirty="0"/>
                </a:p>
              </p:txBody>
            </p:sp>
            <p:sp>
              <p:nvSpPr>
                <p:cNvPr id="523" name="TextBox 42">
                  <a:extLst>
                    <a:ext uri="{FF2B5EF4-FFF2-40B4-BE49-F238E27FC236}">
                      <a16:creationId xmlns:a16="http://schemas.microsoft.com/office/drawing/2014/main" xmlns="" id="{6F2BCFDA-B8A9-4A54-9495-5BB144ECE2CF}"/>
                    </a:ext>
                  </a:extLst>
                </p:cNvPr>
                <p:cNvSpPr txBox="1"/>
                <p:nvPr/>
              </p:nvSpPr>
              <p:spPr>
                <a:xfrm>
                  <a:off x="8118073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3.48E+04</a:t>
                  </a:r>
                  <a:endParaRPr lang="it-IT" sz="1200" dirty="0"/>
                </a:p>
              </p:txBody>
            </p:sp>
            <p:sp>
              <p:nvSpPr>
                <p:cNvPr id="525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5324148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it-IT" sz="1200" dirty="0" smtClean="0"/>
                    <a:t>1.54E+05</a:t>
                  </a:r>
                  <a:endParaRPr lang="it-IT" sz="1200" dirty="0"/>
                </a:p>
              </p:txBody>
            </p:sp>
            <p:sp>
              <p:nvSpPr>
                <p:cNvPr id="526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6032164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44E+06</a:t>
                  </a:r>
                  <a:endParaRPr lang="it-IT" sz="1200" dirty="0"/>
                </a:p>
              </p:txBody>
            </p:sp>
            <p:sp>
              <p:nvSpPr>
                <p:cNvPr id="527" name="TextBox 42">
                  <a:extLst>
                    <a:ext uri="{FF2B5EF4-FFF2-40B4-BE49-F238E27FC236}">
                      <a16:creationId xmlns:a16="http://schemas.microsoft.com/office/drawing/2014/main" xmlns="" id="{6F2BCFDA-B8A9-4A54-9495-5BB144ECE2CF}"/>
                    </a:ext>
                  </a:extLst>
                </p:cNvPr>
                <p:cNvSpPr txBox="1"/>
                <p:nvPr/>
              </p:nvSpPr>
              <p:spPr>
                <a:xfrm>
                  <a:off x="8823415" y="1906835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36E+05</a:t>
                  </a:r>
                  <a:endParaRPr lang="it-IT" sz="1200" dirty="0"/>
                </a:p>
              </p:txBody>
            </p:sp>
            <p:pic>
              <p:nvPicPr>
                <p:cNvPr id="558" name="Picture 2" descr="K:\## Gene Transfer and Therapy\Elisa Vigna\Met-HGF-ott2018\Shared\in vivo\EXP_Fusion_Proteins\Capan\Exp. 20181219Capan1_L6\20180709\cage A\1dxsx\liver FED20180709173154_SEQ\FED20180709173154_001\FED20180709173154_001.PNG"/>
                <p:cNvPicPr>
                  <a:picLocks noChangeArrowheads="1"/>
                </p:cNvPicPr>
                <p:nvPr/>
              </p:nvPicPr>
              <p:blipFill rotWithShape="1"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825" t="8356" r="39934" b="56382"/>
                <a:stretch/>
              </p:blipFill>
              <p:spPr bwMode="auto">
                <a:xfrm>
                  <a:off x="6091175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59" name="Picture 3" descr="K:\## Gene Transfer and Therapy\Elisa Vigna\Met-HGF-ott2018\Shared\in vivo\EXP_Fusion_Proteins\Capan\Exp. 20181219Capan1_L6\20180709\cage A\1sx\Liver FED20180709181847_SEQ\FED20180709181847_001\FED20180709181847_001.PNG"/>
                <p:cNvPicPr>
                  <a:picLocks noChangeArrowheads="1"/>
                </p:cNvPicPr>
                <p:nvPr/>
              </p:nvPicPr>
              <p:blipFill rotWithShape="1">
                <a:blip r:embed="rId2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553" t="19722" r="44366" b="47179"/>
                <a:stretch/>
              </p:blipFill>
              <p:spPr bwMode="auto">
                <a:xfrm>
                  <a:off x="5395505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1" name="Picture 6" descr="K:\## Gene Transfer and Therapy\Elisa Vigna\Met-HGF-ott2018\Shared\in vivo\EXP_Fusion_Proteins\Capan\Exp. 20181219Capan1_L6\20180709\cage A\2dx\FED20180709175904_001\FED20180709175904_001.PNG"/>
                <p:cNvPicPr>
                  <a:picLocks noChangeArrowheads="1"/>
                </p:cNvPicPr>
                <p:nvPr/>
              </p:nvPicPr>
              <p:blipFill rotWithShape="1"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211" t="22850" r="40192" b="44051"/>
                <a:stretch/>
              </p:blipFill>
              <p:spPr bwMode="auto">
                <a:xfrm>
                  <a:off x="6786845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2" name="Picture 7" descr="K:\## Gene Transfer and Therapy\Elisa Vigna\Met-HGF-ott2018\Shared\in vivo\EXP_Fusion_Proteins\Capan\Exp. 20181219Capan1_L6\20180709\cage A\2dx2sx\liver FED20180709171751_SEQ\FED20180709171751_SEQ.PNG"/>
                <p:cNvPicPr>
                  <a:picLocks noChangeArrowheads="1"/>
                </p:cNvPicPr>
                <p:nvPr/>
              </p:nvPicPr>
              <p:blipFill rotWithShape="1">
                <a:blip r:embed="rId2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738" t="16213" r="33103" b="55353"/>
                <a:stretch/>
              </p:blipFill>
              <p:spPr bwMode="auto">
                <a:xfrm>
                  <a:off x="8178185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3" name="Picture 8" descr="K:\## Gene Transfer and Therapy\Elisa Vigna\Met-HGF-ott2018\Shared\in vivo\EXP_Fusion_Proteins\Capan\Exp. 20181219Capan1_L6\20180709\cage A\2sx\Liver FED20180709175157_SEQ\FED20180709175157_001\FED20180709175157_001.PNG"/>
                <p:cNvPicPr>
                  <a:picLocks noChangeArrowheads="1"/>
                </p:cNvPicPr>
                <p:nvPr/>
              </p:nvPicPr>
              <p:blipFill rotWithShape="1">
                <a:blip r:embed="rId2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824" t="5976" r="39161" b="58978"/>
                <a:stretch/>
              </p:blipFill>
              <p:spPr bwMode="auto">
                <a:xfrm>
                  <a:off x="7482515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4" name="Picture 9" descr="K:\## Gene Transfer and Therapy\Elisa Vigna\Met-HGF-ott2018\Shared\in vivo\EXP_Fusion_Proteins\Capan\Exp. 20181219Capan1_L6\20180709\cage A\NL\Liver FED20180709173625_SEQ\FED20180709173625_001\FED20180709173625_001.PNG"/>
                <p:cNvPicPr>
                  <a:picLocks noChangeArrowheads="1"/>
                </p:cNvPicPr>
                <p:nvPr/>
              </p:nvPicPr>
              <p:blipFill rotWithShape="1">
                <a:blip r:embed="rId2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274" t="14846" r="36453" b="47728"/>
                <a:stretch/>
              </p:blipFill>
              <p:spPr bwMode="auto">
                <a:xfrm>
                  <a:off x="8873853" y="1304303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534" name="TextBox 12">
                <a:extLst>
                  <a:ext uri="{FF2B5EF4-FFF2-40B4-BE49-F238E27FC236}">
                    <a16:creationId xmlns:a16="http://schemas.microsoft.com/office/drawing/2014/main" xmlns="" id="{33C012E8-FD3F-429E-93ED-AA21360520C9}"/>
                  </a:ext>
                </a:extLst>
              </p:cNvPr>
              <p:cNvSpPr txBox="1"/>
              <p:nvPr/>
            </p:nvSpPr>
            <p:spPr>
              <a:xfrm>
                <a:off x="7412965" y="419503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3.48E+04</a:t>
                </a:r>
                <a:endParaRPr lang="it-IT" sz="1200" dirty="0"/>
              </a:p>
            </p:txBody>
          </p:sp>
          <p:sp>
            <p:nvSpPr>
              <p:cNvPr id="535" name="TextBox 32">
                <a:extLst>
                  <a:ext uri="{FF2B5EF4-FFF2-40B4-BE49-F238E27FC236}">
                    <a16:creationId xmlns:a16="http://schemas.microsoft.com/office/drawing/2014/main" xmlns="" id="{615783A9-72BD-4FF3-99B1-573FD2D45ADC}"/>
                  </a:ext>
                </a:extLst>
              </p:cNvPr>
              <p:cNvSpPr txBox="1"/>
              <p:nvPr/>
            </p:nvSpPr>
            <p:spPr>
              <a:xfrm>
                <a:off x="8112615" y="419503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2.36E+04</a:t>
                </a:r>
                <a:endParaRPr lang="it-IT" sz="1200" dirty="0"/>
              </a:p>
            </p:txBody>
          </p:sp>
          <p:sp>
            <p:nvSpPr>
              <p:cNvPr id="536" name="TextBox 58">
                <a:extLst>
                  <a:ext uri="{FF2B5EF4-FFF2-40B4-BE49-F238E27FC236}">
                    <a16:creationId xmlns:a16="http://schemas.microsoft.com/office/drawing/2014/main" xmlns="" id="{30BE3640-52AF-497C-BEF9-ECE4A09F7B07}"/>
                  </a:ext>
                </a:extLst>
              </p:cNvPr>
              <p:cNvSpPr txBox="1"/>
              <p:nvPr/>
            </p:nvSpPr>
            <p:spPr>
              <a:xfrm>
                <a:off x="5309619" y="419503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1.36E+04</a:t>
                </a:r>
                <a:endParaRPr lang="it-IT" sz="1200" dirty="0"/>
              </a:p>
            </p:txBody>
          </p:sp>
          <p:sp>
            <p:nvSpPr>
              <p:cNvPr id="537" name="TextBox 59">
                <a:extLst>
                  <a:ext uri="{FF2B5EF4-FFF2-40B4-BE49-F238E27FC236}">
                    <a16:creationId xmlns:a16="http://schemas.microsoft.com/office/drawing/2014/main" xmlns="" id="{918EF17C-B16C-45FB-8066-3374AFB6C04D}"/>
                  </a:ext>
                </a:extLst>
              </p:cNvPr>
              <p:cNvSpPr txBox="1"/>
              <p:nvPr/>
            </p:nvSpPr>
            <p:spPr>
              <a:xfrm>
                <a:off x="6006872" y="419503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1.84E+04</a:t>
                </a:r>
                <a:endParaRPr lang="it-IT" sz="1200" dirty="0"/>
              </a:p>
            </p:txBody>
          </p:sp>
          <p:sp>
            <p:nvSpPr>
              <p:cNvPr id="538" name="TextBox 60">
                <a:extLst>
                  <a:ext uri="{FF2B5EF4-FFF2-40B4-BE49-F238E27FC236}">
                    <a16:creationId xmlns:a16="http://schemas.microsoft.com/office/drawing/2014/main" xmlns="" id="{74754137-D0F4-4D98-B0FB-F5CDB1E3F479}"/>
                  </a:ext>
                </a:extLst>
              </p:cNvPr>
              <p:cNvSpPr txBox="1"/>
              <p:nvPr/>
            </p:nvSpPr>
            <p:spPr>
              <a:xfrm>
                <a:off x="6705375" y="419503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it-IT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it-IT" sz="1200" dirty="0" smtClean="0"/>
                  <a:t>9.00E+04</a:t>
                </a:r>
                <a:endParaRPr lang="it-IT" sz="1200" dirty="0"/>
              </a:p>
            </p:txBody>
          </p:sp>
          <p:grpSp>
            <p:nvGrpSpPr>
              <p:cNvPr id="20" name="Gruppo 19"/>
              <p:cNvGrpSpPr/>
              <p:nvPr/>
            </p:nvGrpSpPr>
            <p:grpSpPr>
              <a:xfrm>
                <a:off x="5317570" y="3305380"/>
                <a:ext cx="3497845" cy="931844"/>
                <a:chOff x="5317570" y="3305380"/>
                <a:chExt cx="3497845" cy="931844"/>
              </a:xfrm>
            </p:grpSpPr>
            <p:sp>
              <p:nvSpPr>
                <p:cNvPr id="528" name="TextBox 32"/>
                <p:cNvSpPr txBox="1"/>
                <p:nvPr/>
              </p:nvSpPr>
              <p:spPr>
                <a:xfrm>
                  <a:off x="5317570" y="3305380"/>
                  <a:ext cx="88036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DecAb-L6</a:t>
                  </a:r>
                  <a:endParaRPr lang="it-IT" sz="1400" dirty="0"/>
                </a:p>
              </p:txBody>
            </p:sp>
            <p:pic>
              <p:nvPicPr>
                <p:cNvPr id="565" name="Picture 10" descr="K:\## Gene Transfer and Therapy\Elisa Vigna\Met-HGF-ott2018\Shared\in vivo\EXP_Fusion_Proteins\Capan\Exp. 20181219Capan1_L6\20180709\cage C\1dx\liver FED20180709154459_SEQ\FED20180709154459_SEQ.PNG"/>
                <p:cNvPicPr>
                  <a:picLocks noChangeArrowheads="1"/>
                </p:cNvPicPr>
                <p:nvPr/>
              </p:nvPicPr>
              <p:blipFill rotWithShape="1">
                <a:blip r:embed="rId2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318" t="18671" r="34862" b="49561"/>
                <a:stretch/>
              </p:blipFill>
              <p:spPr bwMode="auto">
                <a:xfrm>
                  <a:off x="5374315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6" name="Picture 11" descr="K:\## Gene Transfer and Therapy\Elisa Vigna\Met-HGF-ott2018\Shared\in vivo\EXP_Fusion_Proteins\Capan\Exp. 20181219Capan1_L6\20180709\cage C\1dxsx\FED20180709153517_001\FED20180709153517_001.PNG"/>
                <p:cNvPicPr>
                  <a:picLocks noChangeArrowheads="1"/>
                </p:cNvPicPr>
                <p:nvPr/>
              </p:nvPicPr>
              <p:blipFill rotWithShape="1">
                <a:blip r:embed="rId2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406" t="31287" r="44060" b="36695"/>
                <a:stretch/>
              </p:blipFill>
              <p:spPr bwMode="auto">
                <a:xfrm>
                  <a:off x="6770865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7" name="Picture 12" descr="K:\## Gene Transfer and Therapy\Elisa Vigna\Met-HGF-ott2018\Shared\in vivo\EXP_Fusion_Proteins\Capan\Exp. 20181219Capan1_L6\20180709\cage C\1sx\liver FED20180709160120_SEQ\FED20180709160120_SEQ.PNG"/>
                <p:cNvPicPr>
                  <a:picLocks noChangeArrowheads="1"/>
                </p:cNvPicPr>
                <p:nvPr/>
              </p:nvPicPr>
              <p:blipFill rotWithShape="1">
                <a:blip r:embed="rId2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213" t="30781" r="33103" b="36573"/>
                <a:stretch/>
              </p:blipFill>
              <p:spPr bwMode="auto">
                <a:xfrm>
                  <a:off x="6072590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8" name="Picture 13" descr="K:\## Gene Transfer and Therapy\Elisa Vigna\Met-HGF-ott2018\Shared\in vivo\EXP_Fusion_Proteins\Capan\Exp. 20181219Capan1_L6\20180709\cage C\2sx\FED20180709155301_001\FED20180709155301_001.PNG"/>
                <p:cNvPicPr>
                  <a:picLocks noChangeArrowheads="1"/>
                </p:cNvPicPr>
                <p:nvPr/>
              </p:nvPicPr>
              <p:blipFill rotWithShape="1">
                <a:blip r:embed="rId3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730" t="43185" r="43802" b="20903"/>
                <a:stretch/>
              </p:blipFill>
              <p:spPr bwMode="auto">
                <a:xfrm>
                  <a:off x="7469140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69" name="Picture 14" descr="K:\## Gene Transfer and Therapy\Elisa Vigna\Met-HGF-ott2018\Shared\in vivo\EXP_Fusion_Proteins\Capan\Exp. 20181219Capan1_L6\20180709\cage C\NL\FED20180709161130_001\FED20180709161130_001.PNG"/>
                <p:cNvPicPr>
                  <a:picLocks noChangeArrowheads="1"/>
                </p:cNvPicPr>
                <p:nvPr/>
              </p:nvPicPr>
              <p:blipFill rotWithShape="1">
                <a:blip r:embed="rId3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308" t="18523" r="42126" b="49243"/>
                <a:stretch/>
              </p:blipFill>
              <p:spPr bwMode="auto">
                <a:xfrm>
                  <a:off x="8167415" y="358922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21" name="Gruppo 20"/>
              <p:cNvGrpSpPr/>
              <p:nvPr/>
            </p:nvGrpSpPr>
            <p:grpSpPr>
              <a:xfrm>
                <a:off x="5297399" y="4448121"/>
                <a:ext cx="4259572" cy="1165461"/>
                <a:chOff x="5297399" y="4448121"/>
                <a:chExt cx="4259572" cy="1165461"/>
              </a:xfrm>
            </p:grpSpPr>
            <p:sp>
              <p:nvSpPr>
                <p:cNvPr id="539" name="TextBox 51"/>
                <p:cNvSpPr txBox="1"/>
                <p:nvPr/>
              </p:nvSpPr>
              <p:spPr>
                <a:xfrm>
                  <a:off x="5317570" y="4448121"/>
                  <a:ext cx="88036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AbDec-L6</a:t>
                  </a:r>
                  <a:endParaRPr lang="it-IT" sz="1400" dirty="0"/>
                </a:p>
              </p:txBody>
            </p:sp>
            <p:sp>
              <p:nvSpPr>
                <p:cNvPr id="546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7391088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2.29E+04</a:t>
                  </a:r>
                  <a:endParaRPr lang="it-IT" sz="1200" dirty="0"/>
                </a:p>
              </p:txBody>
            </p:sp>
            <p:sp>
              <p:nvSpPr>
                <p:cNvPr id="547" name="TextBox 32">
                  <a:extLst>
                    <a:ext uri="{FF2B5EF4-FFF2-40B4-BE49-F238E27FC236}">
                      <a16:creationId xmlns:a16="http://schemas.microsoft.com/office/drawing/2014/main" xmlns="" id="{615783A9-72BD-4FF3-99B1-573FD2D45ADC}"/>
                    </a:ext>
                  </a:extLst>
                </p:cNvPr>
                <p:cNvSpPr txBox="1"/>
                <p:nvPr/>
              </p:nvSpPr>
              <p:spPr>
                <a:xfrm>
                  <a:off x="8092241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5.35E+04</a:t>
                  </a:r>
                  <a:endParaRPr lang="it-IT" sz="1200" dirty="0"/>
                </a:p>
              </p:txBody>
            </p:sp>
            <p:sp>
              <p:nvSpPr>
                <p:cNvPr id="548" name="TextBox 42">
                  <a:extLst>
                    <a:ext uri="{FF2B5EF4-FFF2-40B4-BE49-F238E27FC236}">
                      <a16:creationId xmlns:a16="http://schemas.microsoft.com/office/drawing/2014/main" xmlns="" id="{6F2BCFDA-B8A9-4A54-9495-5BB144ECE2CF}"/>
                    </a:ext>
                  </a:extLst>
                </p:cNvPr>
                <p:cNvSpPr txBox="1"/>
                <p:nvPr/>
              </p:nvSpPr>
              <p:spPr>
                <a:xfrm>
                  <a:off x="8788812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7.36E+04</a:t>
                  </a:r>
                  <a:endParaRPr lang="it-IT" sz="1200" dirty="0"/>
                </a:p>
              </p:txBody>
            </p:sp>
            <p:sp>
              <p:nvSpPr>
                <p:cNvPr id="549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5297399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3.78E+04</a:t>
                  </a:r>
                  <a:endParaRPr lang="it-IT" sz="1200" dirty="0"/>
                </a:p>
              </p:txBody>
            </p:sp>
            <p:sp>
              <p:nvSpPr>
                <p:cNvPr id="550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5990611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70E+04</a:t>
                  </a:r>
                  <a:endParaRPr lang="it-IT" sz="1200" dirty="0"/>
                </a:p>
              </p:txBody>
            </p:sp>
            <p:sp>
              <p:nvSpPr>
                <p:cNvPr id="551" name="TextBox 60">
                  <a:extLst>
                    <a:ext uri="{FF2B5EF4-FFF2-40B4-BE49-F238E27FC236}">
                      <a16:creationId xmlns:a16="http://schemas.microsoft.com/office/drawing/2014/main" xmlns="" id="{74754137-D0F4-4D98-B0FB-F5CDB1E3F479}"/>
                    </a:ext>
                  </a:extLst>
                </p:cNvPr>
                <p:cNvSpPr txBox="1"/>
                <p:nvPr/>
              </p:nvSpPr>
              <p:spPr>
                <a:xfrm>
                  <a:off x="6690915" y="5336583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2.91E+04</a:t>
                  </a:r>
                  <a:endParaRPr lang="it-IT" sz="1200" dirty="0"/>
                </a:p>
              </p:txBody>
            </p:sp>
            <p:pic>
              <p:nvPicPr>
                <p:cNvPr id="553" name="Picture 14" descr="K:\## Gene Transfer and Therapy\Elisa Vigna\Met-HGF-ott2018\Shared\in vivo\EXP_Fusion_Proteins\Capan\Exp. 20181219Capan1_L6\20180709\cage D\1dx FED20180709163929_001\FED20180709163929_001.PNG"/>
                <p:cNvPicPr>
                  <a:picLocks noChangeArrowheads="1"/>
                </p:cNvPicPr>
                <p:nvPr/>
              </p:nvPicPr>
              <p:blipFill rotWithShape="1">
                <a:blip r:embed="rId3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054" t="13331" r="45994" b="52488"/>
                <a:stretch/>
              </p:blipFill>
              <p:spPr bwMode="auto">
                <a:xfrm>
                  <a:off x="536244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54" name="Picture 15" descr="K:\## Gene Transfer and Therapy\Elisa Vigna\Met-HGF-ott2018\Shared\in vivo\EXP_Fusion_Proteins\Capan\Exp. 20181219Capan1_L6\20180709\cage D\1sx FED20180709164923_001\FED20180709164923_001.PNG"/>
                <p:cNvPicPr>
                  <a:picLocks noChangeArrowheads="1"/>
                </p:cNvPicPr>
                <p:nvPr/>
              </p:nvPicPr>
              <p:blipFill rotWithShape="1">
                <a:blip r:embed="rId3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828" t="18091" r="42255" b="50108"/>
                <a:stretch/>
              </p:blipFill>
              <p:spPr bwMode="auto">
                <a:xfrm>
                  <a:off x="605910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55" name="Picture 16" descr="K:\## Gene Transfer and Therapy\Elisa Vigna\Met-HGF-ott2018\Shared\in vivo\EXP_Fusion_Proteins\Capan\Exp. 20181219Capan1_L6\20180709\cage D\1dxsx FED20180709170804_001\FED20180709170804_001.PNG"/>
                <p:cNvPicPr>
                  <a:picLocks noChangeArrowheads="1"/>
                </p:cNvPicPr>
                <p:nvPr/>
              </p:nvPicPr>
              <p:blipFill rotWithShape="1">
                <a:blip r:embed="rId3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086" t="8788" r="43028" b="53353"/>
                <a:stretch/>
              </p:blipFill>
              <p:spPr bwMode="auto">
                <a:xfrm>
                  <a:off x="675576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56" name="Picture 17" descr="K:\## Gene Transfer and Therapy\Elisa Vigna\Met-HGF-ott2018\Shared\in vivo\EXP_Fusion_Proteins\Capan\Exp. 20181219Capan1_L6\20180709\cage D\2dx FED20180709165828_001\FED20180709165828_001.PNG"/>
                <p:cNvPicPr>
                  <a:picLocks noChangeArrowheads="1"/>
                </p:cNvPicPr>
                <p:nvPr/>
              </p:nvPicPr>
              <p:blipFill rotWithShape="1">
                <a:blip r:embed="rId3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792" t="17010" r="38903" b="50323"/>
                <a:stretch/>
              </p:blipFill>
              <p:spPr bwMode="auto">
                <a:xfrm>
                  <a:off x="745242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57" name="Picture 18" descr="K:\## Gene Transfer and Therapy\Elisa Vigna\Met-HGF-ott2018\Shared\in vivo\EXP_Fusion_Proteins\Capan\Exp. 20181219Capan1_L6\20180709\cage D\2sx FED20180709162141_001\FED20180709162141_001.PNG"/>
                <p:cNvPicPr>
                  <a:picLocks noChangeArrowheads="1"/>
                </p:cNvPicPr>
                <p:nvPr/>
              </p:nvPicPr>
              <p:blipFill rotWithShape="1">
                <a:blip r:embed="rId3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4079" t="24148" r="34777" b="41455"/>
                <a:stretch/>
              </p:blipFill>
              <p:spPr bwMode="auto">
                <a:xfrm>
                  <a:off x="814908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70" name="Picture 15" descr="K:\## Gene Transfer and Therapy\Elisa Vigna\Met-HGF-ott2018\Shared\in vivo\EXP_Fusion_Proteins\Capan\Exp. 20181219Capan1_L6\20180709\cage D\NL\FED20180709162141_001\FED20180709162141_001.PNG"/>
                <p:cNvPicPr>
                  <a:picLocks noChangeArrowheads="1"/>
                </p:cNvPicPr>
                <p:nvPr/>
              </p:nvPicPr>
              <p:blipFill rotWithShape="1">
                <a:blip r:embed="rId3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4982" t="24148" r="36195" b="42104"/>
                <a:stretch/>
              </p:blipFill>
              <p:spPr bwMode="auto">
                <a:xfrm>
                  <a:off x="8845740" y="4734381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19" name="Gruppo 18"/>
              <p:cNvGrpSpPr/>
              <p:nvPr/>
            </p:nvGrpSpPr>
            <p:grpSpPr>
              <a:xfrm>
                <a:off x="5299726" y="2163360"/>
                <a:ext cx="3573913" cy="1162090"/>
                <a:chOff x="5299726" y="2163360"/>
                <a:chExt cx="3573913" cy="1162090"/>
              </a:xfrm>
            </p:grpSpPr>
            <p:pic>
              <p:nvPicPr>
                <p:cNvPr id="1031" name="Picture 7" descr="K:\## Gene Transfer and Therapy\Elisa Vigna\Met-HGF and microenviroment\Shared\Chiara\in vivo\EXP_Fusion_Proteins\Capan\Exp. 20181219Capan1_L6\20180709\cage B\FED20180710160356_001\FED20180710160356_001.PNG"/>
                <p:cNvPicPr>
                  <a:picLocks noChangeArrowheads="1"/>
                </p:cNvPicPr>
                <p:nvPr/>
              </p:nvPicPr>
              <p:blipFill rotWithShape="1">
                <a:blip r:embed="rId3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4878" t="16959" r="46979" b="52114"/>
                <a:stretch/>
              </p:blipFill>
              <p:spPr bwMode="auto">
                <a:xfrm>
                  <a:off x="5362440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4" name="Picture 10" descr="K:\## Gene Transfer and Therapy\Elisa Vigna\Met-HGF and microenviroment\Shared\Chiara\in vivo\EXP_Fusion_Proteins\Capan\Exp. 20181219Capan1_L6\20180709\cage B\FED20180710161222_001\FED20180710161222_001.PNG"/>
                <p:cNvPicPr>
                  <a:picLocks noChangeArrowheads="1"/>
                </p:cNvPicPr>
                <p:nvPr/>
              </p:nvPicPr>
              <p:blipFill rotWithShape="1">
                <a:blip r:embed="rId3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350" t="21790" r="37763" b="47524"/>
                <a:stretch/>
              </p:blipFill>
              <p:spPr bwMode="auto">
                <a:xfrm>
                  <a:off x="6062319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6" name="Picture 12" descr="K:\## Gene Transfer and Therapy\Elisa Vigna\Met-HGF and microenviroment\Shared\Chiara\in vivo\EXP_Fusion_Proteins\Capan\Exp. 20181219Capan1_L6\20180709\cage B\FED20180710154611_001\FED20180710154611_001.PNG"/>
                <p:cNvPicPr>
                  <a:picLocks noChangeArrowheads="1"/>
                </p:cNvPicPr>
                <p:nvPr/>
              </p:nvPicPr>
              <p:blipFill rotWithShape="1">
                <a:blip r:embed="rId4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318" t="27832" r="42947" b="41241"/>
                <a:stretch/>
              </p:blipFill>
              <p:spPr bwMode="auto">
                <a:xfrm>
                  <a:off x="6762197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7" name="Picture 13" descr="K:\## Gene Transfer and Therapy\Elisa Vigna\Met-HGF and microenviroment\Shared\Chiara\in vivo\EXP_Fusion_Proteins\Capan\Exp. 20181219Capan1_L6\20180709\cage B\FED20180710162103_001\FED20180710162103_001.PNG"/>
                <p:cNvPicPr>
                  <a:picLocks noChangeArrowheads="1"/>
                </p:cNvPicPr>
                <p:nvPr/>
              </p:nvPicPr>
              <p:blipFill rotWithShape="1">
                <a:blip r:embed="rId4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062" t="25416" r="39778" b="45107"/>
                <a:stretch/>
              </p:blipFill>
              <p:spPr bwMode="auto">
                <a:xfrm>
                  <a:off x="7462075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9" name="Picture 15" descr="K:\## Gene Transfer and Therapy\Elisa Vigna\Met-HGF and microenviroment\Shared\Chiara\in vivo\EXP_Fusion_Proteins\Capan\Exp. 20181219Capan1_L6\20180709\cage B\FED20180710163156_001\FED20180710163156_001.PNG"/>
                <p:cNvPicPr>
                  <a:picLocks noChangeArrowheads="1"/>
                </p:cNvPicPr>
                <p:nvPr/>
              </p:nvPicPr>
              <p:blipFill rotWithShape="1">
                <a:blip r:embed="rId4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758" t="17442" r="39923" b="48732"/>
                <a:stretch/>
              </p:blipFill>
              <p:spPr bwMode="auto">
                <a:xfrm>
                  <a:off x="8161954" y="2453254"/>
                  <a:ext cx="648000" cy="648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16" name="TextBox 12">
                  <a:extLst>
                    <a:ext uri="{FF2B5EF4-FFF2-40B4-BE49-F238E27FC236}">
                      <a16:creationId xmlns:a16="http://schemas.microsoft.com/office/drawing/2014/main" xmlns="" id="{33C012E8-FD3F-429E-93ED-AA21360520C9}"/>
                    </a:ext>
                  </a:extLst>
                </p:cNvPr>
                <p:cNvSpPr txBox="1"/>
                <p:nvPr/>
              </p:nvSpPr>
              <p:spPr>
                <a:xfrm>
                  <a:off x="6705121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00E+04</a:t>
                  </a:r>
                  <a:endParaRPr lang="it-IT" sz="1200" dirty="0"/>
                </a:p>
              </p:txBody>
            </p:sp>
            <p:sp>
              <p:nvSpPr>
                <p:cNvPr id="117" name="TextBox 32">
                  <a:extLst>
                    <a:ext uri="{FF2B5EF4-FFF2-40B4-BE49-F238E27FC236}">
                      <a16:creationId xmlns:a16="http://schemas.microsoft.com/office/drawing/2014/main" xmlns="" id="{615783A9-72BD-4FF3-99B1-573FD2D45ADC}"/>
                    </a:ext>
                  </a:extLst>
                </p:cNvPr>
                <p:cNvSpPr txBox="1"/>
                <p:nvPr/>
              </p:nvSpPr>
              <p:spPr>
                <a:xfrm>
                  <a:off x="7408909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1.23E+04</a:t>
                  </a:r>
                  <a:endParaRPr lang="it-IT" sz="1200" dirty="0"/>
                </a:p>
              </p:txBody>
            </p:sp>
            <p:sp>
              <p:nvSpPr>
                <p:cNvPr id="118" name="TextBox 42">
                  <a:extLst>
                    <a:ext uri="{FF2B5EF4-FFF2-40B4-BE49-F238E27FC236}">
                      <a16:creationId xmlns:a16="http://schemas.microsoft.com/office/drawing/2014/main" xmlns="" id="{6F2BCFDA-B8A9-4A54-9495-5BB144ECE2CF}"/>
                    </a:ext>
                  </a:extLst>
                </p:cNvPr>
                <p:cNvSpPr txBox="1"/>
                <p:nvPr/>
              </p:nvSpPr>
              <p:spPr>
                <a:xfrm>
                  <a:off x="8105480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4.48E+04</a:t>
                  </a:r>
                  <a:endParaRPr lang="it-IT" sz="1200" dirty="0"/>
                </a:p>
              </p:txBody>
            </p:sp>
            <p:sp>
              <p:nvSpPr>
                <p:cNvPr id="119" name="TextBox 58">
                  <a:extLst>
                    <a:ext uri="{FF2B5EF4-FFF2-40B4-BE49-F238E27FC236}">
                      <a16:creationId xmlns:a16="http://schemas.microsoft.com/office/drawing/2014/main" xmlns="" id="{30BE3640-52AF-497C-BEF9-ECE4A09F7B07}"/>
                    </a:ext>
                  </a:extLst>
                </p:cNvPr>
                <p:cNvSpPr txBox="1"/>
                <p:nvPr/>
              </p:nvSpPr>
              <p:spPr>
                <a:xfrm>
                  <a:off x="5299726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it-IT" sz="1200" dirty="0" smtClean="0"/>
                    <a:t>5.27E+04</a:t>
                  </a:r>
                  <a:endParaRPr lang="it-IT" sz="1200" dirty="0"/>
                </a:p>
              </p:txBody>
            </p:sp>
            <p:sp>
              <p:nvSpPr>
                <p:cNvPr id="120" name="TextBox 59">
                  <a:extLst>
                    <a:ext uri="{FF2B5EF4-FFF2-40B4-BE49-F238E27FC236}">
                      <a16:creationId xmlns:a16="http://schemas.microsoft.com/office/drawing/2014/main" xmlns="" id="{918EF17C-B16C-45FB-8066-3374AFB6C04D}"/>
                    </a:ext>
                  </a:extLst>
                </p:cNvPr>
                <p:cNvSpPr txBox="1"/>
                <p:nvPr/>
              </p:nvSpPr>
              <p:spPr>
                <a:xfrm>
                  <a:off x="5998924" y="3048451"/>
                  <a:ext cx="7681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it-IT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it-IT" sz="1200" dirty="0" smtClean="0"/>
                    <a:t>9.40E+04</a:t>
                  </a:r>
                  <a:endParaRPr lang="it-IT" sz="1200" dirty="0"/>
                </a:p>
              </p:txBody>
            </p:sp>
            <p:sp>
              <p:nvSpPr>
                <p:cNvPr id="122" name="TextBox 45"/>
                <p:cNvSpPr txBox="1"/>
                <p:nvPr/>
              </p:nvSpPr>
              <p:spPr>
                <a:xfrm>
                  <a:off x="5317570" y="2163360"/>
                  <a:ext cx="77963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400" dirty="0" smtClean="0"/>
                    <a:t>COMBO</a:t>
                  </a:r>
                  <a:endParaRPr lang="it-IT" sz="14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827832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0</TotalTime>
  <Words>111</Words>
  <Application>Microsoft Office PowerPoint</Application>
  <PresentationFormat>A4 Paper (210x297 mm)</PresentationFormat>
  <Paragraphs>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url</dc:creator>
  <cp:lastModifiedBy>Cristina Basilico</cp:lastModifiedBy>
  <cp:revision>265</cp:revision>
  <cp:lastPrinted>2020-07-16T13:47:19Z</cp:lastPrinted>
  <dcterms:created xsi:type="dcterms:W3CDTF">2020-06-04T13:45:57Z</dcterms:created>
  <dcterms:modified xsi:type="dcterms:W3CDTF">2020-12-18T14:24:23Z</dcterms:modified>
</cp:coreProperties>
</file>